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EB6328-679A-4981-BD48-8DA05A9AE0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8C0FC-0FE2-4C1D-B99F-C8F717F4B2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CA847-C897-4AFE-B93D-0EA3F6406A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4AF4B-CECB-45B2-814E-4509E7A35B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54C83-F3AD-4934-89AD-8D93C8ABFB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DACD8-48FE-4CAF-9467-36E74DEBCA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B0B1C-5A06-4E52-A59E-C37DD043D3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000F0-6B7C-42DE-A34D-4D24DA0AEC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334A1-985B-41CC-8A2A-72E872B77D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8E80A6-7F7F-4709-A2FE-E3B8C76313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1648BF-1C88-4873-BF84-FB48386B54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F8377-CF31-436B-B112-AB6F6D2704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D0E040-E005-4D8C-8E7E-7A1B22C39C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169920" y="523800"/>
            <a:ext cx="449280" cy="212760"/>
            <a:chOff x="169920" y="523800"/>
            <a:chExt cx="449280" cy="212760"/>
          </a:xfrm>
        </p:grpSpPr>
        <p:sp>
          <p:nvSpPr>
            <p:cNvPr id="42" name="Rectangle 3"/>
            <p:cNvSpPr/>
            <p:nvPr/>
          </p:nvSpPr>
          <p:spPr>
            <a:xfrm>
              <a:off x="169920" y="523800"/>
              <a:ext cx="449280" cy="212760"/>
            </a:xfrm>
            <a:prstGeom prst="rect">
              <a:avLst/>
            </a:prstGeom>
            <a:solidFill>
              <a:srgbClr val="3399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4"/>
            <p:cNvSpPr/>
            <p:nvPr/>
          </p:nvSpPr>
          <p:spPr>
            <a:xfrm>
              <a:off x="200160" y="5414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VY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Group 5"/>
          <p:cNvGrpSpPr/>
          <p:nvPr/>
        </p:nvGrpSpPr>
        <p:grpSpPr>
          <a:xfrm>
            <a:off x="3725640" y="523800"/>
            <a:ext cx="371160" cy="214560"/>
            <a:chOff x="3725640" y="523800"/>
            <a:chExt cx="371160" cy="214560"/>
          </a:xfrm>
        </p:grpSpPr>
        <p:sp>
          <p:nvSpPr>
            <p:cNvPr id="45" name="Rectangle 6"/>
            <p:cNvSpPr/>
            <p:nvPr/>
          </p:nvSpPr>
          <p:spPr>
            <a:xfrm>
              <a:off x="3803400" y="523800"/>
              <a:ext cx="214200" cy="214560"/>
            </a:xfrm>
            <a:prstGeom prst="rect">
              <a:avLst/>
            </a:prstGeom>
            <a:solidFill>
              <a:srgbClr val="99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3725640" y="5396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Text Box 8"/>
          <p:cNvSpPr/>
          <p:nvPr/>
        </p:nvSpPr>
        <p:spPr>
          <a:xfrm>
            <a:off x="4751280" y="476280"/>
            <a:ext cx="1843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9"/>
          <p:cNvGrpSpPr/>
          <p:nvPr/>
        </p:nvGrpSpPr>
        <p:grpSpPr>
          <a:xfrm>
            <a:off x="4037040" y="523800"/>
            <a:ext cx="726840" cy="212760"/>
            <a:chOff x="4037040" y="523800"/>
            <a:chExt cx="726840" cy="212760"/>
          </a:xfrm>
        </p:grpSpPr>
        <p:sp>
          <p:nvSpPr>
            <p:cNvPr id="49" name="Rectangle 10"/>
            <p:cNvSpPr/>
            <p:nvPr/>
          </p:nvSpPr>
          <p:spPr>
            <a:xfrm>
              <a:off x="4037040" y="523800"/>
              <a:ext cx="726840" cy="212760"/>
            </a:xfrm>
            <a:prstGeom prst="rect">
              <a:avLst/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1"/>
            <p:cNvSpPr/>
            <p:nvPr/>
          </p:nvSpPr>
          <p:spPr>
            <a:xfrm>
              <a:off x="4037760" y="54108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PIY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Group 12"/>
          <p:cNvGrpSpPr/>
          <p:nvPr/>
        </p:nvGrpSpPr>
        <p:grpSpPr>
          <a:xfrm>
            <a:off x="582840" y="523800"/>
            <a:ext cx="371160" cy="214560"/>
            <a:chOff x="582840" y="523800"/>
            <a:chExt cx="371160" cy="214560"/>
          </a:xfrm>
        </p:grpSpPr>
        <p:sp>
          <p:nvSpPr>
            <p:cNvPr id="52" name="Rectangle 13"/>
            <p:cNvSpPr/>
            <p:nvPr/>
          </p:nvSpPr>
          <p:spPr>
            <a:xfrm>
              <a:off x="638280" y="523800"/>
              <a:ext cx="257040" cy="214560"/>
            </a:xfrm>
            <a:prstGeom prst="rect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4"/>
            <p:cNvSpPr/>
            <p:nvPr/>
          </p:nvSpPr>
          <p:spPr>
            <a:xfrm>
              <a:off x="582840" y="53820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Group 15"/>
          <p:cNvGrpSpPr/>
          <p:nvPr/>
        </p:nvGrpSpPr>
        <p:grpSpPr>
          <a:xfrm>
            <a:off x="917640" y="523800"/>
            <a:ext cx="449280" cy="212760"/>
            <a:chOff x="917640" y="523800"/>
            <a:chExt cx="449280" cy="212760"/>
          </a:xfrm>
        </p:grpSpPr>
        <p:sp>
          <p:nvSpPr>
            <p:cNvPr id="55" name="Rectangle 16"/>
            <p:cNvSpPr/>
            <p:nvPr/>
          </p:nvSpPr>
          <p:spPr>
            <a:xfrm>
              <a:off x="917640" y="523800"/>
              <a:ext cx="449280" cy="212760"/>
            </a:xfrm>
            <a:prstGeom prst="rect">
              <a:avLst/>
            </a:prstGeom>
            <a:solidFill>
              <a:srgbClr val="3399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7"/>
            <p:cNvSpPr/>
            <p:nvPr/>
          </p:nvSpPr>
          <p:spPr>
            <a:xfrm>
              <a:off x="947880" y="5414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Group 18"/>
          <p:cNvGrpSpPr/>
          <p:nvPr/>
        </p:nvGrpSpPr>
        <p:grpSpPr>
          <a:xfrm>
            <a:off x="1327320" y="523800"/>
            <a:ext cx="371160" cy="214560"/>
            <a:chOff x="1327320" y="523800"/>
            <a:chExt cx="371160" cy="214560"/>
          </a:xfrm>
        </p:grpSpPr>
        <p:sp>
          <p:nvSpPr>
            <p:cNvPr id="58" name="Rectangle 19"/>
            <p:cNvSpPr/>
            <p:nvPr/>
          </p:nvSpPr>
          <p:spPr>
            <a:xfrm>
              <a:off x="1382760" y="523800"/>
              <a:ext cx="257040" cy="214560"/>
            </a:xfrm>
            <a:prstGeom prst="rect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0"/>
            <p:cNvSpPr/>
            <p:nvPr/>
          </p:nvSpPr>
          <p:spPr>
            <a:xfrm>
              <a:off x="1327320" y="53820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Group 21"/>
          <p:cNvGrpSpPr/>
          <p:nvPr/>
        </p:nvGrpSpPr>
        <p:grpSpPr>
          <a:xfrm>
            <a:off x="1658880" y="523800"/>
            <a:ext cx="449280" cy="212760"/>
            <a:chOff x="1658880" y="523800"/>
            <a:chExt cx="449280" cy="212760"/>
          </a:xfrm>
        </p:grpSpPr>
        <p:sp>
          <p:nvSpPr>
            <p:cNvPr id="61" name="Rectangle 22"/>
            <p:cNvSpPr/>
            <p:nvPr/>
          </p:nvSpPr>
          <p:spPr>
            <a:xfrm>
              <a:off x="1658880" y="523800"/>
              <a:ext cx="449280" cy="212760"/>
            </a:xfrm>
            <a:prstGeom prst="rect">
              <a:avLst/>
            </a:prstGeom>
            <a:solidFill>
              <a:srgbClr val="3399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23"/>
            <p:cNvSpPr/>
            <p:nvPr/>
          </p:nvSpPr>
          <p:spPr>
            <a:xfrm>
              <a:off x="1689120" y="5414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Group 24"/>
          <p:cNvGrpSpPr/>
          <p:nvPr/>
        </p:nvGrpSpPr>
        <p:grpSpPr>
          <a:xfrm>
            <a:off x="2068560" y="523800"/>
            <a:ext cx="371160" cy="214560"/>
            <a:chOff x="2068560" y="523800"/>
            <a:chExt cx="371160" cy="214560"/>
          </a:xfrm>
        </p:grpSpPr>
        <p:sp>
          <p:nvSpPr>
            <p:cNvPr id="64" name="Rectangle 25"/>
            <p:cNvSpPr/>
            <p:nvPr/>
          </p:nvSpPr>
          <p:spPr>
            <a:xfrm>
              <a:off x="2124000" y="523800"/>
              <a:ext cx="257040" cy="214560"/>
            </a:xfrm>
            <a:prstGeom prst="rect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6"/>
            <p:cNvSpPr/>
            <p:nvPr/>
          </p:nvSpPr>
          <p:spPr>
            <a:xfrm>
              <a:off x="2068560" y="53820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Group 27"/>
          <p:cNvGrpSpPr/>
          <p:nvPr/>
        </p:nvGrpSpPr>
        <p:grpSpPr>
          <a:xfrm>
            <a:off x="2400480" y="523800"/>
            <a:ext cx="448920" cy="212760"/>
            <a:chOff x="2400480" y="523800"/>
            <a:chExt cx="448920" cy="212760"/>
          </a:xfrm>
        </p:grpSpPr>
        <p:sp>
          <p:nvSpPr>
            <p:cNvPr id="67" name="Rectangle 28"/>
            <p:cNvSpPr/>
            <p:nvPr/>
          </p:nvSpPr>
          <p:spPr>
            <a:xfrm>
              <a:off x="2400480" y="523800"/>
              <a:ext cx="448920" cy="212760"/>
            </a:xfrm>
            <a:prstGeom prst="rect">
              <a:avLst/>
            </a:prstGeom>
            <a:solidFill>
              <a:srgbClr val="3399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9"/>
            <p:cNvSpPr/>
            <p:nvPr/>
          </p:nvSpPr>
          <p:spPr>
            <a:xfrm>
              <a:off x="2430360" y="5414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" name="Group 30"/>
          <p:cNvGrpSpPr/>
          <p:nvPr/>
        </p:nvGrpSpPr>
        <p:grpSpPr>
          <a:xfrm>
            <a:off x="2814840" y="523800"/>
            <a:ext cx="371160" cy="214560"/>
            <a:chOff x="2814840" y="523800"/>
            <a:chExt cx="371160" cy="214560"/>
          </a:xfrm>
        </p:grpSpPr>
        <p:sp>
          <p:nvSpPr>
            <p:cNvPr id="70" name="Rectangle 31"/>
            <p:cNvSpPr/>
            <p:nvPr/>
          </p:nvSpPr>
          <p:spPr>
            <a:xfrm>
              <a:off x="2870280" y="523800"/>
              <a:ext cx="257040" cy="214560"/>
            </a:xfrm>
            <a:prstGeom prst="rect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2"/>
            <p:cNvSpPr/>
            <p:nvPr/>
          </p:nvSpPr>
          <p:spPr>
            <a:xfrm>
              <a:off x="2814840" y="53820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" name="Group 33"/>
          <p:cNvGrpSpPr/>
          <p:nvPr/>
        </p:nvGrpSpPr>
        <p:grpSpPr>
          <a:xfrm>
            <a:off x="3147840" y="523800"/>
            <a:ext cx="449280" cy="212760"/>
            <a:chOff x="3147840" y="523800"/>
            <a:chExt cx="449280" cy="212760"/>
          </a:xfrm>
        </p:grpSpPr>
        <p:sp>
          <p:nvSpPr>
            <p:cNvPr id="73" name="Rectangle 34"/>
            <p:cNvSpPr/>
            <p:nvPr/>
          </p:nvSpPr>
          <p:spPr>
            <a:xfrm>
              <a:off x="3147840" y="523800"/>
              <a:ext cx="449280" cy="212760"/>
            </a:xfrm>
            <a:prstGeom prst="rect">
              <a:avLst/>
            </a:prstGeom>
            <a:solidFill>
              <a:srgbClr val="3399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5"/>
            <p:cNvSpPr/>
            <p:nvPr/>
          </p:nvSpPr>
          <p:spPr>
            <a:xfrm>
              <a:off x="3178080" y="5414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ourier New"/>
                </a:rPr>
                <a:t>ESIY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Rectangle 36"/>
          <p:cNvSpPr/>
          <p:nvPr/>
        </p:nvSpPr>
        <p:spPr>
          <a:xfrm>
            <a:off x="3613320" y="523800"/>
            <a:ext cx="171360" cy="214560"/>
          </a:xfrm>
          <a:prstGeom prst="rect">
            <a:avLst/>
          </a:prstGeom>
          <a:solidFill>
            <a:srgbClr val="993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37"/>
          <p:cNvSpPr/>
          <p:nvPr/>
        </p:nvSpPr>
        <p:spPr>
          <a:xfrm>
            <a:off x="90720" y="112680"/>
            <a:ext cx="530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omposition of the C-terminal end of cluster V Ank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38"/>
          <p:cNvSpPr/>
          <p:nvPr/>
        </p:nvSpPr>
        <p:spPr>
          <a:xfrm>
            <a:off x="71280" y="877680"/>
            <a:ext cx="85442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egend to Additional file 3: Figure S1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e composition of the C-terminal end of cluster V AnkA from 27 voles and shrews is shown. Homologous protein domains are displayed in same colors. Tyrosine phosphorylation motifs predicted by Scansite (http://scansite.mit.edu/) are indicated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07T19:01:31Z</dcterms:created>
  <dc:creator>Friederike von Loewenich</dc:creator>
  <dc:description/>
  <dc:language>en-US</dc:language>
  <cp:lastModifiedBy>Somoza, Jesun</cp:lastModifiedBy>
  <dcterms:modified xsi:type="dcterms:W3CDTF">2013-12-03T11:32:48Z</dcterms:modified>
  <cp:revision>7</cp:revision>
  <dc:subject/>
  <dc:title>Folie 1</dc:title>
</cp:coreProperties>
</file>